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559675" cy="10691813"/>
  <p:notesSz cx="6800850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004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6799320" cy="9931320"/>
          </a:xfrm>
          <a:custGeom>
            <a:avLst/>
            <a:gdLst>
              <a:gd name="textAreaLeft" fmla="*/ 360 w 6799320"/>
              <a:gd name="textAreaRight" fmla="*/ 6798960 w 6799320"/>
              <a:gd name="textAreaTop" fmla="*/ 360 h 9931320"/>
              <a:gd name="textAreaBottom" fmla="*/ 9930960 h 9931320"/>
            </a:gdLst>
            <a:ahLst/>
            <a:rect l="textAreaLeft" t="textAreaTop" r="textAreaRight" b="textAreaBottom"/>
            <a:pathLst>
              <a:path w="21600" h="31549">
                <a:moveTo>
                  <a:pt x="4" y="0"/>
                </a:moveTo>
                <a:arcTo wR="4" hR="4" stAng="16200000" swAng="-5400000"/>
                <a:lnTo>
                  <a:pt x="0" y="31545"/>
                </a:lnTo>
                <a:arcTo wR="4" hR="4" stAng="10800000" swAng="-5400000"/>
                <a:lnTo>
                  <a:pt x="21596" y="31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5680" rIns="85680" tIns="42840" bIns="4284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sldImg"/>
          </p:nvPr>
        </p:nvSpPr>
        <p:spPr>
          <a:xfrm>
            <a:off x="2082600" y="754200"/>
            <a:ext cx="2631960" cy="37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680760" y="4716000"/>
            <a:ext cx="5437080" cy="446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hdr"/>
          </p:nvPr>
        </p:nvSpPr>
        <p:spPr>
          <a:xfrm>
            <a:off x="-360" y="-3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dt" idx="4"/>
          </p:nvPr>
        </p:nvSpPr>
        <p:spPr>
          <a:xfrm>
            <a:off x="3847680" y="-3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5"/>
          </p:nvPr>
        </p:nvSpPr>
        <p:spPr>
          <a:xfrm>
            <a:off x="-360" y="94341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 type="sldNum" idx="6"/>
          </p:nvPr>
        </p:nvSpPr>
        <p:spPr>
          <a:xfrm>
            <a:off x="3847680" y="94341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28760"/>
                <a:tab algn="l" pos="857160"/>
                <a:tab algn="l" pos="1285920"/>
                <a:tab algn="l" pos="1714680"/>
                <a:tab algn="l" pos="2143080"/>
                <a:tab algn="l" pos="2573280"/>
                <a:tab algn="l" pos="3002040"/>
                <a:tab algn="l" pos="3430440"/>
                <a:tab algn="l" pos="3859200"/>
                <a:tab algn="l" pos="4287960"/>
                <a:tab algn="l" pos="4716360"/>
                <a:tab algn="l" pos="5146560"/>
                <a:tab algn="l" pos="5575320"/>
                <a:tab algn="l" pos="6004080"/>
                <a:tab algn="l" pos="6432480"/>
                <a:tab algn="l" pos="6861240"/>
                <a:tab algn="l" pos="7289640"/>
                <a:tab algn="l" pos="7719840"/>
                <a:tab algn="l" pos="8148600"/>
                <a:tab algn="l" pos="857736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300" spc="-1" strike="noStrike">
                <a:solidFill>
                  <a:srgbClr val="000000"/>
                </a:solidFill>
                <a:latin typeface="Times New Roman"/>
                <a:ea typeface="MS PGothic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28760"/>
                <a:tab algn="l" pos="857160"/>
                <a:tab algn="l" pos="1285920"/>
                <a:tab algn="l" pos="1714680"/>
                <a:tab algn="l" pos="2143080"/>
                <a:tab algn="l" pos="2573280"/>
                <a:tab algn="l" pos="3002040"/>
                <a:tab algn="l" pos="3430440"/>
                <a:tab algn="l" pos="3859200"/>
                <a:tab algn="l" pos="4287960"/>
                <a:tab algn="l" pos="4716360"/>
                <a:tab algn="l" pos="5146560"/>
                <a:tab algn="l" pos="5575320"/>
                <a:tab algn="l" pos="6004080"/>
                <a:tab algn="l" pos="6432480"/>
                <a:tab algn="l" pos="6861240"/>
                <a:tab algn="l" pos="7289640"/>
                <a:tab algn="l" pos="7719840"/>
                <a:tab algn="l" pos="8148600"/>
                <a:tab algn="l" pos="857736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12E0B5CD-E57D-4720-B0DC-85547245129F}" type="slidenum">
              <a:rPr b="0" lang="en-US" sz="1300" spc="-1" strike="noStrike">
                <a:solidFill>
                  <a:srgbClr val="000000"/>
                </a:solidFill>
                <a:latin typeface="Times New Roman"/>
                <a:ea typeface="MS PGothic"/>
              </a:rPr>
              <a:t>&lt;number&gt;</a:t>
            </a:fld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Rectangle 7"/>
          <p:cNvSpPr/>
          <p:nvPr/>
        </p:nvSpPr>
        <p:spPr>
          <a:xfrm>
            <a:off x="3848040" y="9434520"/>
            <a:ext cx="29480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28760"/>
                <a:tab algn="l" pos="857160"/>
                <a:tab algn="l" pos="1285920"/>
                <a:tab algn="l" pos="1714680"/>
                <a:tab algn="l" pos="2143080"/>
                <a:tab algn="l" pos="2571840"/>
                <a:tab algn="l" pos="3000240"/>
                <a:tab algn="l" pos="3429000"/>
                <a:tab algn="l" pos="3859200"/>
                <a:tab algn="l" pos="4287960"/>
                <a:tab algn="l" pos="4716360"/>
                <a:tab algn="l" pos="5145120"/>
                <a:tab algn="l" pos="5573880"/>
                <a:tab algn="l" pos="6002280"/>
                <a:tab algn="l" pos="6431040"/>
                <a:tab algn="l" pos="6859440"/>
                <a:tab algn="l" pos="7288200"/>
                <a:tab algn="l" pos="7718400"/>
                <a:tab algn="l" pos="8148600"/>
                <a:tab algn="l" pos="857736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C45B84DC-5BE2-4B69-BB51-575753727510}" type="slidenum">
              <a:rPr b="0" lang="en-US" sz="1300" spc="-1" strike="noStrike">
                <a:solidFill>
                  <a:srgbClr val="000000"/>
                </a:solidFill>
                <a:latin typeface="Times New Roman"/>
                <a:ea typeface="MS PGothic"/>
              </a:rPr>
              <a:t>&lt;number&gt;</a:t>
            </a:fld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2082960" y="754200"/>
            <a:ext cx="2633400" cy="37242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0760" y="4716360"/>
            <a:ext cx="5437080" cy="446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Times New Roman"/>
              <a:ea typeface="MS PGothic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2A05F-E660-45FE-A4D3-0C8421F492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542045-8F2A-4F49-829E-0C266D7E8F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C9297-574A-4044-B47C-5368308219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84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916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80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84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916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F1D40-A64F-4913-B5D0-6C2245146E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9226C-7282-4A79-9155-CD70B3867A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8373AA-35D6-4596-A8F9-4C6F3BB5B5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C0AD7-54AC-48F0-9E07-7F97D1AA46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B8873-0BB1-4EF3-93AC-B1D909F484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28400"/>
            <a:ext cx="6804000" cy="825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5BECE-E63B-4415-8751-24C10AEE91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73972-2125-4991-83BE-2097BE95DB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898C7-8D40-40AD-8118-2E3DC961AF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FEBC7-53AC-4019-9841-A2C33B48FF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909000"/>
            <a:ext cx="176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2640" y="9909000"/>
            <a:ext cx="239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8000" y="9909000"/>
            <a:ext cx="176400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Arial"/>
                <a:ea typeface="MS PGothic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5730CC5-1FEC-4AC7-8D2B-5FB169BD8975}" type="slidenum">
              <a:rPr b="0" lang="en-US" sz="1200" spc="-1" strike="noStrike">
                <a:solidFill>
                  <a:srgbClr val="898989"/>
                </a:solidFill>
                <a:latin typeface="Arial"/>
                <a:ea typeface="MS PGothic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360360" y="1008000"/>
            <a:ext cx="3257640" cy="3257640"/>
          </a:xfrm>
          <a:prstGeom prst="rect">
            <a:avLst/>
          </a:prstGeom>
          <a:ln w="0">
            <a:noFill/>
          </a:ln>
        </p:spPr>
      </p:pic>
      <p:pic>
        <p:nvPicPr>
          <p:cNvPr id="50" name="図 4" descr="human_all_GC.png"/>
          <p:cNvPicPr/>
          <p:nvPr/>
        </p:nvPicPr>
        <p:blipFill>
          <a:blip r:embed="rId2"/>
          <a:stretch/>
        </p:blipFill>
        <p:spPr>
          <a:xfrm>
            <a:off x="3976560" y="934920"/>
            <a:ext cx="3259440" cy="3259080"/>
          </a:xfrm>
          <a:prstGeom prst="rect">
            <a:avLst/>
          </a:prstGeom>
          <a:ln w="0">
            <a:noFill/>
          </a:ln>
        </p:spPr>
      </p:pic>
      <p:pic>
        <p:nvPicPr>
          <p:cNvPr id="51" name="図 5" descr="human_CpG_GC.png"/>
          <p:cNvPicPr/>
          <p:nvPr/>
        </p:nvPicPr>
        <p:blipFill>
          <a:blip r:embed="rId3"/>
          <a:stretch/>
        </p:blipFill>
        <p:spPr>
          <a:xfrm>
            <a:off x="235080" y="4896000"/>
            <a:ext cx="3259080" cy="3259080"/>
          </a:xfrm>
          <a:prstGeom prst="rect">
            <a:avLst/>
          </a:prstGeom>
          <a:ln w="0">
            <a:noFill/>
          </a:ln>
        </p:spPr>
      </p:pic>
      <p:pic>
        <p:nvPicPr>
          <p:cNvPr id="52" name="図 6" descr="human_nonCpG_GC.png"/>
          <p:cNvPicPr/>
          <p:nvPr/>
        </p:nvPicPr>
        <p:blipFill>
          <a:blip r:embed="rId4"/>
          <a:stretch/>
        </p:blipFill>
        <p:spPr>
          <a:xfrm>
            <a:off x="3976560" y="4896000"/>
            <a:ext cx="3259440" cy="3259080"/>
          </a:xfrm>
          <a:prstGeom prst="rect">
            <a:avLst/>
          </a:prstGeom>
          <a:ln w="0">
            <a:noFill/>
          </a:ln>
        </p:spPr>
      </p:pic>
      <p:sp>
        <p:nvSpPr>
          <p:cNvPr id="53" name="テキスト ボックス 6"/>
          <p:cNvSpPr/>
          <p:nvPr/>
        </p:nvSpPr>
        <p:spPr>
          <a:xfrm>
            <a:off x="202320" y="473076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C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テキスト ボックス 7"/>
          <p:cNvSpPr/>
          <p:nvPr/>
        </p:nvSpPr>
        <p:spPr>
          <a:xfrm>
            <a:off x="3639240" y="473076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D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テキスト ボックス 8"/>
          <p:cNvSpPr/>
          <p:nvPr/>
        </p:nvSpPr>
        <p:spPr>
          <a:xfrm>
            <a:off x="202320" y="102564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テキスト ボックス 9"/>
          <p:cNvSpPr/>
          <p:nvPr/>
        </p:nvSpPr>
        <p:spPr>
          <a:xfrm>
            <a:off x="3639240" y="102564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7" name="Rectangle 10"/>
          <p:cNvSpPr/>
          <p:nvPr/>
        </p:nvSpPr>
        <p:spPr>
          <a:xfrm>
            <a:off x="4410000" y="4842000"/>
            <a:ext cx="2808360" cy="3650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Rectangle 11"/>
          <p:cNvSpPr/>
          <p:nvPr/>
        </p:nvSpPr>
        <p:spPr>
          <a:xfrm>
            <a:off x="593640" y="4842000"/>
            <a:ext cx="2808360" cy="3650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Rectangle 12"/>
          <p:cNvSpPr/>
          <p:nvPr/>
        </p:nvSpPr>
        <p:spPr>
          <a:xfrm>
            <a:off x="4410000" y="880920"/>
            <a:ext cx="2808360" cy="3654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Rectangle 13"/>
          <p:cNvSpPr/>
          <p:nvPr/>
        </p:nvSpPr>
        <p:spPr>
          <a:xfrm>
            <a:off x="593640" y="947880"/>
            <a:ext cx="2808360" cy="3650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TextBox 15"/>
          <p:cNvSpPr/>
          <p:nvPr/>
        </p:nvSpPr>
        <p:spPr>
          <a:xfrm>
            <a:off x="971640" y="4021200"/>
            <a:ext cx="212076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2" name="TextBox 16"/>
          <p:cNvSpPr/>
          <p:nvPr/>
        </p:nvSpPr>
        <p:spPr>
          <a:xfrm>
            <a:off x="4643280" y="4021200"/>
            <a:ext cx="2121120" cy="318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  <a:ea typeface="MS PGothic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3" name="TextBox 17"/>
          <p:cNvSpPr/>
          <p:nvPr/>
        </p:nvSpPr>
        <p:spPr>
          <a:xfrm>
            <a:off x="971640" y="7910640"/>
            <a:ext cx="2120760" cy="318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  <a:ea typeface="MS PGothic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TextBox 18"/>
          <p:cNvSpPr/>
          <p:nvPr/>
        </p:nvSpPr>
        <p:spPr>
          <a:xfrm>
            <a:off x="4643280" y="7908840"/>
            <a:ext cx="2121120" cy="318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  <a:ea typeface="MS PGothic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TextBox 19"/>
          <p:cNvSpPr/>
          <p:nvPr/>
        </p:nvSpPr>
        <p:spPr>
          <a:xfrm rot="16200000">
            <a:off x="-305280" y="2556360"/>
            <a:ext cx="139572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Frequency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TextBox 20"/>
          <p:cNvSpPr/>
          <p:nvPr/>
        </p:nvSpPr>
        <p:spPr>
          <a:xfrm rot="16200000">
            <a:off x="2745360" y="2458080"/>
            <a:ext cx="2494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TextBox 21"/>
          <p:cNvSpPr/>
          <p:nvPr/>
        </p:nvSpPr>
        <p:spPr>
          <a:xfrm rot="16200000">
            <a:off x="2745720" y="6345720"/>
            <a:ext cx="249372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" name="TextBox 22"/>
          <p:cNvSpPr/>
          <p:nvPr/>
        </p:nvSpPr>
        <p:spPr>
          <a:xfrm rot="16200000">
            <a:off x="-992520" y="6345720"/>
            <a:ext cx="249372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5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3T09:27:06Z</dcterms:created>
  <dc:creator>Alexis Vandenbon</dc:creator>
  <dc:description/>
  <dc:language>en-US</dc:language>
  <cp:lastModifiedBy>alexvdb</cp:lastModifiedBy>
  <dcterms:modified xsi:type="dcterms:W3CDTF">2012-03-21T13:17:25Z</dcterms:modified>
  <cp:revision>218</cp:revision>
  <dc:subject/>
  <dc:title>スライド 1</dc:title>
</cp:coreProperties>
</file>